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4660"/>
  </p:normalViewPr>
  <p:slideViewPr>
    <p:cSldViewPr snapToGrid="0">
      <p:cViewPr varScale="1">
        <p:scale>
          <a:sx n="78" d="100"/>
          <a:sy n="78" d="100"/>
        </p:scale>
        <p:origin x="89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51879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3764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91490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56738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61003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39085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1306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02602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27367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79037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27762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48EEBA-EF94-4FA9-BB73-A7732504AC0A}" type="datetimeFigureOut">
              <a:rPr kumimoji="1" lang="ja-JP" altLang="en-US" smtClean="0"/>
              <a:t>2021/12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BB64D5-016E-41CE-BD30-C42B0614B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10558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025" descr="C:\Users\shige\Desktop\Xe-changes-HBF_spleen.bmp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6013" y="33338"/>
            <a:ext cx="6911975" cy="68564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テキスト ボックス 3"/>
          <p:cNvSpPr txBox="1"/>
          <p:nvPr/>
        </p:nvSpPr>
        <p:spPr>
          <a:xfrm>
            <a:off x="195444" y="160544"/>
            <a:ext cx="34691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3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695308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277586" y="373618"/>
            <a:ext cx="8401050" cy="131940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3. </a:t>
            </a:r>
            <a:r>
              <a:rPr lang="en-US" altLang="ja-JP" sz="1400" b="1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Xe</a:t>
            </a:r>
            <a:r>
              <a:rPr lang="en-US" altLang="ja-JP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-CT protocol</a:t>
            </a:r>
            <a:endParaRPr lang="ja-JP" altLang="ja-JP" sz="14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indent="66675"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he wash-in and wash-out periods were of 4 min. The entire liver was CT-scanned at 1-min intervals at four levels, including the porta </a:t>
            </a:r>
            <a:r>
              <a:rPr lang="en-US" altLang="ja-JP" sz="14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hepatis</a:t>
            </a: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nine scans in total, including the baseline scan).</a:t>
            </a:r>
            <a:endParaRPr lang="ja-JP" altLang="ja-JP" sz="1400" kern="10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458803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6</Words>
  <Application>Microsoft Office PowerPoint</Application>
  <PresentationFormat>画面に合わせる (4:3)</PresentationFormat>
  <Paragraphs>3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9" baseType="lpstr">
      <vt:lpstr>ＭＳ Ｐゴシック</vt:lpstr>
      <vt:lpstr>ＭＳ 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重福 隆太</dc:creator>
  <cp:lastModifiedBy>重福 隆太</cp:lastModifiedBy>
  <cp:revision>4</cp:revision>
  <dcterms:created xsi:type="dcterms:W3CDTF">2021-10-17T09:25:07Z</dcterms:created>
  <dcterms:modified xsi:type="dcterms:W3CDTF">2021-12-23T16:42:27Z</dcterms:modified>
</cp:coreProperties>
</file>